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492" y="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C460E0D-32F2-432B-BEC5-5CF6AB1246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E93BF757-7349-4E29-9DCB-A8703067503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9D7E6DD-D132-4AC3-BE7C-245AB01F15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CFD16-36DD-4A52-98D6-2EF4948C64A0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34EE20E-9BAB-4E50-A47C-E3332475A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A2577EF-C888-4D2D-BC73-877FF2D8D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C5AE-E099-4C7B-8265-08ADA8012F6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7493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E763D4B-4038-44B7-84E5-41C68B8226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BB2A064-50F4-4D51-A916-A6C5E5E3E8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83CCAE2-75E1-4DA2-9882-2A3CD3D7AB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CFD16-36DD-4A52-98D6-2EF4948C64A0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28B4FA3-9066-41C5-AB1D-AB20CA9759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4DEAF87-D425-4CE1-85EB-51F59BF812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C5AE-E099-4C7B-8265-08ADA8012F6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423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F4CE6057-87A8-4CD6-96AA-29B75EB720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5E39B06-1BC1-497C-AFA3-A36BDB8787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7475E64-72F1-4411-8AAD-EF8C422DEF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CFD16-36DD-4A52-98D6-2EF4948C64A0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4B85359-A6C2-435A-BE28-38FB2FD55F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63194B2-5AF9-4A91-B830-7C2D3BC908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C5AE-E099-4C7B-8265-08ADA8012F6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957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75857D7-F035-4CBD-BF77-1A01B1BC13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78902B8-9B45-4F4F-891E-BEFAD51C9A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2D1A43F-D93C-4BA3-ABD3-E5327084D1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CFD16-36DD-4A52-98D6-2EF4948C64A0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0891456-90A6-45DE-A700-B2B35B736F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8A0C67B-2296-4615-98C9-645A58CD74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C5AE-E099-4C7B-8265-08ADA8012F6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865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9E1FF5F-8F77-42F2-B6EB-A469750EDD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3139419-E391-4196-A638-BC0C8CB632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47F70A8-29AF-4035-A84A-315F02F9D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CFD16-36DD-4A52-98D6-2EF4948C64A0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F8E3029-0C1E-495D-A1C8-85E1BBB8E8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6B8C81C-AB8C-4E0C-83B9-ABF8455D83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C5AE-E099-4C7B-8265-08ADA8012F6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6600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6A8427A-A71D-4616-8B87-A34AFE9345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3E60AD5-6CE8-48D1-BC70-22647765D8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449921D-CB32-405D-8D14-C53C753754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F6D4365-9560-43B2-A9F0-B498C2FF38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CFD16-36DD-4A52-98D6-2EF4948C64A0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5893094-771F-4541-B92E-CD0A3C8A53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CF30889-A548-4F4B-886B-E78AFC645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C5AE-E099-4C7B-8265-08ADA8012F6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3600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CF1815F-2BFD-41DC-9314-91C983606C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886BFC5-92E3-4263-BB3B-EC7DBA1F36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FD8048B-123F-46FB-9FD8-612F741386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D84721D2-06F2-4EE0-909E-FFB0A3F6F80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DC1E62FF-FAD3-40CC-9EB8-40252363153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C23D1DD-C46D-4373-9FFF-D0C9F68555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CFD16-36DD-4A52-98D6-2EF4948C64A0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80896E2-99D9-42D5-AD70-75E00D13DA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D32CA20C-7BF6-419F-8BBF-ED63CB237B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C5AE-E099-4C7B-8265-08ADA8012F6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3216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5D85B67-29EF-44DD-9CA3-AF2914B3AC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C8B9FEC5-215F-4B53-A1D1-7FBA242494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CFD16-36DD-4A52-98D6-2EF4948C64A0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01120B66-9A9D-406A-92B3-F8C2D8152F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6D6FC8DE-43FE-4DD1-8699-5B7D047EF7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C5AE-E099-4C7B-8265-08ADA8012F6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0468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09FCA4FA-E875-4003-8935-40D02B1C8D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CFD16-36DD-4A52-98D6-2EF4948C64A0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5B5C2BE5-C715-4177-AC3D-42D08F2562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94F9F9B5-BA60-4478-B422-12BF44D558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C5AE-E099-4C7B-8265-08ADA8012F6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208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051F594-EA4F-4A91-A829-C65C740A08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0FD5D2E-88D9-4D57-9DA1-5ACFE1DBE0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25DF87F-B6B2-4353-B3CB-9D3E96B9D7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93EC629-4F29-4D02-AA55-93ABAE5A61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CFD16-36DD-4A52-98D6-2EF4948C64A0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E286FC4-584A-4C34-90BD-8B31B0B7DA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27A7551-F3C4-400B-94A2-EC27125F6A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C5AE-E099-4C7B-8265-08ADA8012F6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2191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FEEE4C3-8E77-44C8-842A-7F3B299AB1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F7AD589-8091-4152-9151-F89EF4B3CC8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054BC1F2-7316-4FD8-B37D-B5257086EE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63A944E-9EE4-4A47-B59E-8A4397EC8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CFD16-36DD-4A52-98D6-2EF4948C64A0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418AF24-DACF-447D-8579-045A60F8BF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BDCEB91-88D6-4716-A151-CDDAD978AF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C5AE-E099-4C7B-8265-08ADA8012F6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019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8978BFE7-4F10-4160-BFAE-60E6D1BEE7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61AAAC4-2766-4B20-BFB7-6C7529D0A8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627E597-5C48-4CA7-9BB7-92C1AE6C2A6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2CFD16-36DD-4A52-98D6-2EF4948C64A0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9EAD3D9-7AE3-48BD-9B59-D4A5FD1EC89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689C501-4888-469F-A5EA-90D2E3CF72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B8C5AE-E099-4C7B-8265-08ADA8012F6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586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14F1DFCF-0E8F-4B15-9164-C2E14A8C28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3255" y="1406421"/>
            <a:ext cx="9525490" cy="4045158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33AADAF6-05F8-4F8F-980C-D270C27E6AC8}"/>
              </a:ext>
            </a:extLst>
          </p:cNvPr>
          <p:cNvSpPr txBox="1"/>
          <p:nvPr/>
        </p:nvSpPr>
        <p:spPr>
          <a:xfrm>
            <a:off x="732711" y="96892"/>
            <a:ext cx="1002833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>
                <a:latin typeface="Times New Roman" panose="02020603050405020304" pitchFamily="18" charset="0"/>
                <a:cs typeface="Times New Roman" panose="02020603050405020304" pitchFamily="18" charset="0"/>
              </a:rPr>
              <a:t>Figure S3: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pSet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showing families with more than three intersecting group of samples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Number of families for each group and intersection are reported</a:t>
            </a:r>
          </a:p>
        </p:txBody>
      </p:sp>
    </p:spTree>
    <p:extLst>
      <p:ext uri="{BB962C8B-B14F-4D97-AF65-F5344CB8AC3E}">
        <p14:creationId xmlns:p14="http://schemas.microsoft.com/office/powerpoint/2010/main" val="262533656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drea Laconi</dc:creator>
  <cp:lastModifiedBy>Andrea Laconi</cp:lastModifiedBy>
  <cp:revision>1</cp:revision>
  <dcterms:created xsi:type="dcterms:W3CDTF">2024-07-02T09:40:27Z</dcterms:created>
  <dcterms:modified xsi:type="dcterms:W3CDTF">2024-07-02T09:40:35Z</dcterms:modified>
</cp:coreProperties>
</file>